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840" y="6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381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620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120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301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510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668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773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795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205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279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189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106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9A66730-051F-4C63-B3E3-7649E9A047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7566" y="304184"/>
            <a:ext cx="6372449" cy="454476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D340158-F98E-4FA6-AD64-B0076CA1C5A8}"/>
              </a:ext>
            </a:extLst>
          </p:cNvPr>
          <p:cNvSpPr txBox="1"/>
          <p:nvPr/>
        </p:nvSpPr>
        <p:spPr>
          <a:xfrm>
            <a:off x="1227597" y="5014831"/>
            <a:ext cx="7737983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on between SNP markers in the region spanning 28.609 – 28.998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b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chromosome 11. Two linkage blocks can be discerned; the left block marked by the red triangle (28.681 – 28.798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b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tains the peak marker (C11-28757650) identified through multi-location GWAS, plus several other markers significantly associated with high grain Zn concentrations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6E54107-C1C5-4DC8-AED3-E971BB715119}"/>
              </a:ext>
            </a:extLst>
          </p:cNvPr>
          <p:cNvSpPr txBox="1"/>
          <p:nvPr/>
        </p:nvSpPr>
        <p:spPr>
          <a:xfrm>
            <a:off x="1227597" y="5968938"/>
            <a:ext cx="6674741" cy="845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omic prediction of zinc-biofortification potential in rice gene bank accessions</a:t>
            </a:r>
          </a:p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kotondramanan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 et al. (2022) Theoretical and Applied Genetics</a:t>
            </a:r>
          </a:p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author: Matthias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ssuw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issuwa@affrc.go.jp</a:t>
            </a:r>
          </a:p>
        </p:txBody>
      </p:sp>
    </p:spTree>
    <p:extLst>
      <p:ext uri="{BB962C8B-B14F-4D97-AF65-F5344CB8AC3E}">
        <p14:creationId xmlns:p14="http://schemas.microsoft.com/office/powerpoint/2010/main" val="49975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6</TotalTime>
  <Words>98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Juan</cp:lastModifiedBy>
  <cp:revision>34</cp:revision>
  <dcterms:created xsi:type="dcterms:W3CDTF">2021-06-16T10:29:06Z</dcterms:created>
  <dcterms:modified xsi:type="dcterms:W3CDTF">2022-04-12T01:43:45Z</dcterms:modified>
</cp:coreProperties>
</file>